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5" r:id="rId4"/>
  </p:sldMasterIdLst>
  <p:notesMasterIdLst>
    <p:notesMasterId r:id="rId6"/>
  </p:notes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37" userDrawn="1">
          <p15:clr>
            <a:srgbClr val="A4A3A4"/>
          </p15:clr>
        </p15:guide>
        <p15:guide id="2" orient="horz" pos="864" userDrawn="1">
          <p15:clr>
            <a:srgbClr val="A4A3A4"/>
          </p15:clr>
        </p15:guide>
        <p15:guide id="3" pos="3841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5D28D2C-A15A-4F9E-C674-BA49FD7F46D4}" name="For Client" initials="FC" userId="For Client" providerId="None"/>
  <p188:author id="{26E818CE-A316-1E82-BBC0-53F227660CAE}" name="Counsellor, Charlene" initials="CC" userId="S::Charlene.Counsellor@precisionvh.com::37f46a64-e0c9-4d4e-b184-5b6e0367a7b4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For Authors" initials="MF" lastIdx="3" clrIdx="6">
    <p:extLst>
      <p:ext uri="{19B8F6BF-5375-455C-9EA6-DF929625EA0E}">
        <p15:presenceInfo xmlns:p15="http://schemas.microsoft.com/office/powerpoint/2012/main" userId="For Authors" providerId="None"/>
      </p:ext>
    </p:extLst>
  </p:cmAuthor>
  <p:cmAuthor id="1" name="Dee Rodriguez" initials="DR" lastIdx="1" clrIdx="0">
    <p:extLst>
      <p:ext uri="{19B8F6BF-5375-455C-9EA6-DF929625EA0E}">
        <p15:presenceInfo xmlns:p15="http://schemas.microsoft.com/office/powerpoint/2012/main" userId="S::drodriguez@allovir.com::47ad2ce2-d880-4468-b4c8-d0f1cf065b67" providerId="AD"/>
      </p:ext>
    </p:extLst>
  </p:cmAuthor>
  <p:cmAuthor id="8" name="Leichner, Theresa" initials="LT" lastIdx="1" clrIdx="7">
    <p:extLst>
      <p:ext uri="{19B8F6BF-5375-455C-9EA6-DF929625EA0E}">
        <p15:presenceInfo xmlns:p15="http://schemas.microsoft.com/office/powerpoint/2012/main" userId="S::Theresa.Leichner@precisionvh.com::8127f48e-8a2f-4e32-ba53-02c84d0d2bfb" providerId="AD"/>
      </p:ext>
    </p:extLst>
  </p:cmAuthor>
  <p:cmAuthor id="2" name="Michelle Matzko" initials="MM" lastIdx="44" clrIdx="1">
    <p:extLst>
      <p:ext uri="{19B8F6BF-5375-455C-9EA6-DF929625EA0E}">
        <p15:presenceInfo xmlns:p15="http://schemas.microsoft.com/office/powerpoint/2012/main" userId="S::mmatzko@allovir.com::1a4e03fa-f91b-4823-8dc8-434f0eeddc9c" providerId="AD"/>
      </p:ext>
    </p:extLst>
  </p:cmAuthor>
  <p:cmAuthor id="9" name="Myers, Rebecca" initials="RM" lastIdx="3" clrIdx="8">
    <p:extLst>
      <p:ext uri="{19B8F6BF-5375-455C-9EA6-DF929625EA0E}">
        <p15:presenceInfo xmlns:p15="http://schemas.microsoft.com/office/powerpoint/2012/main" userId="Myers, Rebecca" providerId="None"/>
      </p:ext>
    </p:extLst>
  </p:cmAuthor>
  <p:cmAuthor id="3" name="Seung Hyun Moon" initials="SHM" lastIdx="27" clrIdx="2">
    <p:extLst>
      <p:ext uri="{19B8F6BF-5375-455C-9EA6-DF929625EA0E}">
        <p15:presenceInfo xmlns:p15="http://schemas.microsoft.com/office/powerpoint/2012/main" userId="S::shmoon@allovir.com::ec11b979-fea6-4598-b6cd-284e3bd9ae73" providerId="AD"/>
      </p:ext>
    </p:extLst>
  </p:cmAuthor>
  <p:cmAuthor id="4" name="Michael Miller" initials="MM" lastIdx="1" clrIdx="3">
    <p:extLst>
      <p:ext uri="{19B8F6BF-5375-455C-9EA6-DF929625EA0E}">
        <p15:presenceInfo xmlns:p15="http://schemas.microsoft.com/office/powerpoint/2012/main" userId="S::mmiller@allovir.com::b06f1e5d-4ac8-4fab-8552-dafd9e02caf6" providerId="AD"/>
      </p:ext>
    </p:extLst>
  </p:cmAuthor>
  <p:cmAuthor id="5" name="Keith Boundy" initials="KB" lastIdx="11" clrIdx="4">
    <p:extLst>
      <p:ext uri="{19B8F6BF-5375-455C-9EA6-DF929625EA0E}">
        <p15:presenceInfo xmlns:p15="http://schemas.microsoft.com/office/powerpoint/2012/main" userId="S::kboundy@allovir.com::5eceb316-a050-424d-ba31-920f51103e01" providerId="AD"/>
      </p:ext>
    </p:extLst>
  </p:cmAuthor>
  <p:cmAuthor id="6" name="David McNeel" initials="DM" lastIdx="8" clrIdx="5">
    <p:extLst>
      <p:ext uri="{19B8F6BF-5375-455C-9EA6-DF929625EA0E}">
        <p15:presenceInfo xmlns:p15="http://schemas.microsoft.com/office/powerpoint/2012/main" userId="S::dmcneel@allovir.com::395aecf9-440c-499a-b011-4ffe58cf4c3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21B5D"/>
    <a:srgbClr val="0000FF"/>
    <a:srgbClr val="682B91"/>
    <a:srgbClr val="FF9900"/>
    <a:srgbClr val="D7D8EF"/>
    <a:srgbClr val="A1A1A1"/>
    <a:srgbClr val="CC6600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270" autoAdjust="0"/>
    <p:restoredTop sz="96190" autoAdjust="0"/>
  </p:normalViewPr>
  <p:slideViewPr>
    <p:cSldViewPr snapToGrid="0" showGuides="1">
      <p:cViewPr varScale="1">
        <p:scale>
          <a:sx n="119" d="100"/>
          <a:sy n="119" d="100"/>
        </p:scale>
        <p:origin x="1352" y="184"/>
      </p:cViewPr>
      <p:guideLst>
        <p:guide orient="horz" pos="3637"/>
        <p:guide orient="horz" pos="864"/>
        <p:guide pos="384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94AB1D-5DEE-42AD-8802-4EAD131D8D41}" type="datetimeFigureOut">
              <a:rPr lang="en-US" smtClean="0"/>
              <a:t>5/25/22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A2AF2F-B622-477F-A5E6-A34CA0400B5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28832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1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051" algn="l" defTabSz="9141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103" algn="l" defTabSz="9141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153" algn="l" defTabSz="9141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206" algn="l" defTabSz="9141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256" algn="l" defTabSz="9141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309" algn="l" defTabSz="9141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358" algn="l" defTabSz="9141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409" algn="l" defTabSz="9141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841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741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802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394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979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377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377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816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950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121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5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917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06780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6" r:id="rId1"/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83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        @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TxIDJournal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@</a:t>
            </a:r>
            <a:r>
              <a:rPr lang="en-US" sz="1200" dirty="0" err="1">
                <a:solidFill>
                  <a:prstClr val="white"/>
                </a:solidFill>
                <a:latin typeface="Calibri" panose="020F0502020204030204"/>
              </a:rPr>
              <a:t>MichaelGIsonMD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54" y="668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660292"/>
            <a:ext cx="3257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son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t al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 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ransplant Infectious Disease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 2022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126124" y="-35509"/>
            <a:ext cx="1192347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1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conomic and Clinical Burden Associated With Respiratory Viral Infections After </a:t>
            </a:r>
            <a:b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llogeneic Hematopoietic Cell Transplant in the United States 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1B77EA5E-4F47-440D-AF7E-EC9AE8BF8FE6}"/>
              </a:ext>
            </a:extLst>
          </p:cNvPr>
          <p:cNvSpPr txBox="1"/>
          <p:nvPr/>
        </p:nvSpPr>
        <p:spPr>
          <a:xfrm>
            <a:off x="265506" y="1088168"/>
            <a:ext cx="4435923" cy="200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1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srgbClr val="0C3587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bjective</a:t>
            </a:r>
            <a:b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ssess patient and health care burden of respiratory viral infections (RVIs) after allogeneic hematopoietic cell transplantation (allo-HCT) using an </a:t>
            </a:r>
            <a:b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pen-source claims database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929900CD-F95B-42F6-8BE9-C6AA47D54D0C}"/>
              </a:ext>
            </a:extLst>
          </p:cNvPr>
          <p:cNvGrpSpPr/>
          <p:nvPr/>
        </p:nvGrpSpPr>
        <p:grpSpPr>
          <a:xfrm>
            <a:off x="298260" y="3268958"/>
            <a:ext cx="4358248" cy="2663177"/>
            <a:chOff x="3754784" y="486093"/>
            <a:chExt cx="4266767" cy="2485976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48EF7673-F40F-4F6D-8A92-DB4BAC5C3E2B}"/>
                </a:ext>
              </a:extLst>
            </p:cNvPr>
            <p:cNvGrpSpPr/>
            <p:nvPr/>
          </p:nvGrpSpPr>
          <p:grpSpPr>
            <a:xfrm>
              <a:off x="3754784" y="486093"/>
              <a:ext cx="4266767" cy="2485976"/>
              <a:chOff x="3754784" y="279065"/>
              <a:chExt cx="4266767" cy="2485976"/>
            </a:xfrm>
          </p:grpSpPr>
          <p:cxnSp>
            <p:nvCxnSpPr>
              <p:cNvPr id="19" name="Connector: Elbow 18">
                <a:extLst>
                  <a:ext uri="{FF2B5EF4-FFF2-40B4-BE49-F238E27FC236}">
                    <a16:creationId xmlns:a16="http://schemas.microsoft.com/office/drawing/2014/main" id="{DA6BDB48-CB97-4392-962C-6C6850CB703D}"/>
                  </a:ext>
                </a:extLst>
              </p:cNvPr>
              <p:cNvCxnSpPr>
                <a:cxnSpLocks/>
                <a:endCxn id="23" idx="0"/>
              </p:cNvCxnSpPr>
              <p:nvPr/>
            </p:nvCxnSpPr>
            <p:spPr>
              <a:xfrm rot="10800000" flipV="1">
                <a:off x="4398903" y="1842942"/>
                <a:ext cx="1474319" cy="261312"/>
              </a:xfrm>
              <a:prstGeom prst="bentConnector2">
                <a:avLst/>
              </a:prstGeom>
              <a:noFill/>
              <a:ln w="6350" cap="flat" cmpd="sng" algn="ctr">
                <a:solidFill>
                  <a:srgbClr val="000000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20" name="Connector: Elbow 19">
                <a:extLst>
                  <a:ext uri="{FF2B5EF4-FFF2-40B4-BE49-F238E27FC236}">
                    <a16:creationId xmlns:a16="http://schemas.microsoft.com/office/drawing/2014/main" id="{C8DBA756-7A49-4B75-A541-CDDA7BCE2782}"/>
                  </a:ext>
                </a:extLst>
              </p:cNvPr>
              <p:cNvCxnSpPr>
                <a:cxnSpLocks/>
                <a:endCxn id="24" idx="0"/>
              </p:cNvCxnSpPr>
              <p:nvPr/>
            </p:nvCxnSpPr>
            <p:spPr>
              <a:xfrm>
                <a:off x="5858081" y="1842937"/>
                <a:ext cx="1519355" cy="258223"/>
              </a:xfrm>
              <a:prstGeom prst="bentConnector2">
                <a:avLst/>
              </a:prstGeom>
              <a:noFill/>
              <a:ln w="6350" cap="flat" cmpd="sng" algn="ctr">
                <a:solidFill>
                  <a:srgbClr val="000000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D90D1F5-BC62-4516-9AD3-EB1DE1158D7B}"/>
                  </a:ext>
                </a:extLst>
              </p:cNvPr>
              <p:cNvSpPr txBox="1"/>
              <p:nvPr/>
            </p:nvSpPr>
            <p:spPr>
              <a:xfrm>
                <a:off x="4802847" y="279065"/>
                <a:ext cx="2147142" cy="66078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Ins="91440" rtlCol="0">
                <a:spAutoFit/>
              </a:bodyPr>
              <a:lstStyle/>
              <a:p>
                <a:pPr marL="0" marR="0" lvl="0" indent="0" algn="ctr" defTabSz="91441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2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C3587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13,363 allo-HCTs</a:t>
                </a:r>
                <a:br>
                  <a:rPr kumimoji="0" lang="en-US" sz="2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</a:br>
                <a:r>
                  <a:rPr kumimoji="0" 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2012–2017)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944C48D4-55B6-4A95-A4D6-DBDDCAC24076}"/>
                  </a:ext>
                </a:extLst>
              </p:cNvPr>
              <p:cNvSpPr txBox="1"/>
              <p:nvPr/>
            </p:nvSpPr>
            <p:spPr>
              <a:xfrm>
                <a:off x="4932884" y="2089817"/>
                <a:ext cx="1935068" cy="6607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1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Health Resource Utilization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B952F385-5FCF-4020-B3C8-CFD869E60C92}"/>
                  </a:ext>
                </a:extLst>
              </p:cNvPr>
              <p:cNvSpPr txBox="1"/>
              <p:nvPr/>
            </p:nvSpPr>
            <p:spPr>
              <a:xfrm>
                <a:off x="3754784" y="2104256"/>
                <a:ext cx="1288235" cy="6607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1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Clinical Outcomes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95834D8-4C6D-4F59-917C-02E5542BF114}"/>
                  </a:ext>
                </a:extLst>
              </p:cNvPr>
              <p:cNvSpPr txBox="1"/>
              <p:nvPr/>
            </p:nvSpPr>
            <p:spPr>
              <a:xfrm>
                <a:off x="6733317" y="2101164"/>
                <a:ext cx="1288234" cy="6607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1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20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conomic Outcomes</a:t>
                </a:r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7DA21F1-5EC7-43B1-B751-B51357F4B4FF}"/>
                </a:ext>
              </a:extLst>
            </p:cNvPr>
            <p:cNvSpPr txBox="1"/>
            <p:nvPr/>
          </p:nvSpPr>
          <p:spPr>
            <a:xfrm>
              <a:off x="3945863" y="1308028"/>
              <a:ext cx="3872110" cy="66078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RVI by RSV, influenza, PIV, or hMPV</a:t>
              </a:r>
              <a:b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</a:br>
              <a:r>
                <a:rPr kumimoji="0" lang="en-US" sz="2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(within 1 year of allo-HCT)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6BF83184-04E4-498E-BFE1-8F955566A4C3}"/>
                </a:ext>
              </a:extLst>
            </p:cNvPr>
            <p:cNvCxnSpPr>
              <a:cxnSpLocks/>
              <a:endCxn id="22" idx="0"/>
            </p:cNvCxnSpPr>
            <p:nvPr/>
          </p:nvCxnSpPr>
          <p:spPr>
            <a:xfrm>
              <a:off x="5900419" y="1968813"/>
              <a:ext cx="0" cy="328032"/>
            </a:xfrm>
            <a:prstGeom prst="straightConnector1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miter lim="800000"/>
              <a:tailEnd type="triangle"/>
            </a:ln>
            <a:effectLst/>
          </p:spPr>
        </p:cxnSp>
      </p:grpSp>
      <p:sp>
        <p:nvSpPr>
          <p:cNvPr id="26" name="Rectangle 25">
            <a:extLst>
              <a:ext uri="{FF2B5EF4-FFF2-40B4-BE49-F238E27FC236}">
                <a16:creationId xmlns:a16="http://schemas.microsoft.com/office/drawing/2014/main" id="{917A7C1B-8D11-4C11-BF83-833CB0E7F6BF}"/>
              </a:ext>
            </a:extLst>
          </p:cNvPr>
          <p:cNvSpPr/>
          <p:nvPr/>
        </p:nvSpPr>
        <p:spPr>
          <a:xfrm>
            <a:off x="265506" y="3169747"/>
            <a:ext cx="4435923" cy="2872430"/>
          </a:xfrm>
          <a:prstGeom prst="rect">
            <a:avLst/>
          </a:prstGeom>
          <a:noFill/>
          <a:ln w="19050" cap="flat" cmpd="sng" algn="ctr">
            <a:solidFill>
              <a:srgbClr val="0C3587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1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1" b="0" i="0" u="none" strike="noStrike" kern="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7" name="Picture 6" descr="Patient ">
            <a:extLst>
              <a:ext uri="{FF2B5EF4-FFF2-40B4-BE49-F238E27FC236}">
                <a16:creationId xmlns:a16="http://schemas.microsoft.com/office/drawing/2014/main" id="{5115A849-3149-4FE8-BC36-607755C7E8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35191" y="1073546"/>
            <a:ext cx="721617" cy="7216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CBA6F87B-F82E-4B57-8D2C-76BA4D7FE138}"/>
              </a:ext>
            </a:extLst>
          </p:cNvPr>
          <p:cNvSpPr txBox="1"/>
          <p:nvPr/>
        </p:nvSpPr>
        <p:spPr>
          <a:xfrm>
            <a:off x="6701077" y="1180482"/>
            <a:ext cx="5079243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1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ithin 1 year of allo-HCT, compared to patients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ithout RVIs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, patients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srgbClr val="89160F">
                    <a:lumMod val="60000"/>
                    <a:lumOff val="40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ith any RVI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ad: 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DAF7A4B0-204C-40C8-A247-B34583ED5607}"/>
              </a:ext>
            </a:extLst>
          </p:cNvPr>
          <p:cNvGrpSpPr/>
          <p:nvPr/>
        </p:nvGrpSpPr>
        <p:grpSpPr>
          <a:xfrm>
            <a:off x="5264045" y="1958360"/>
            <a:ext cx="6516943" cy="1290318"/>
            <a:chOff x="1086928" y="3620986"/>
            <a:chExt cx="5943600" cy="972798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7793412-1D49-4347-A9E5-686F7EBA3E02}"/>
                </a:ext>
              </a:extLst>
            </p:cNvPr>
            <p:cNvSpPr txBox="1"/>
            <p:nvPr/>
          </p:nvSpPr>
          <p:spPr>
            <a:xfrm>
              <a:off x="3910601" y="3922717"/>
              <a:ext cx="3119925" cy="30165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601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Higher all-cause mortality risk</a:t>
              </a:r>
            </a:p>
          </p:txBody>
        </p:sp>
        <p:pic>
          <p:nvPicPr>
            <p:cNvPr id="31" name="Picture 4" descr="Increase ">
              <a:extLst>
                <a:ext uri="{FF2B5EF4-FFF2-40B4-BE49-F238E27FC236}">
                  <a16:creationId xmlns:a16="http://schemas.microsoft.com/office/drawing/2014/main" id="{29671F0D-D5BA-4E62-9596-FA8CB84DE96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00527" y="3892471"/>
              <a:ext cx="429827" cy="42982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EF3A088A-DED7-4C66-91B1-3536135D2825}"/>
                </a:ext>
              </a:extLst>
            </p:cNvPr>
            <p:cNvSpPr/>
            <p:nvPr/>
          </p:nvSpPr>
          <p:spPr>
            <a:xfrm>
              <a:off x="2398143" y="3621177"/>
              <a:ext cx="4632385" cy="968784"/>
            </a:xfrm>
            <a:prstGeom prst="rect">
              <a:avLst/>
            </a:prstGeom>
            <a:noFill/>
            <a:ln w="12700" cap="flat" cmpd="sng" algn="ctr">
              <a:solidFill>
                <a:srgbClr val="89160F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3" name="Arrow: Pentagon 32">
              <a:extLst>
                <a:ext uri="{FF2B5EF4-FFF2-40B4-BE49-F238E27FC236}">
                  <a16:creationId xmlns:a16="http://schemas.microsoft.com/office/drawing/2014/main" id="{41926197-21E3-4AA3-BF95-2EBA89148E30}"/>
                </a:ext>
              </a:extLst>
            </p:cNvPr>
            <p:cNvSpPr/>
            <p:nvPr/>
          </p:nvSpPr>
          <p:spPr>
            <a:xfrm>
              <a:off x="1086928" y="3620986"/>
              <a:ext cx="1929395" cy="972798"/>
            </a:xfrm>
            <a:prstGeom prst="homePlate">
              <a:avLst/>
            </a:prstGeom>
            <a:solidFill>
              <a:srgbClr val="89160F"/>
            </a:solidFill>
            <a:ln w="12700" cap="flat" cmpd="sng" algn="ctr">
              <a:solidFill>
                <a:srgbClr val="89160F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E7C40F0-3CE6-44FF-A4C4-DB0EB5C231B7}"/>
                </a:ext>
              </a:extLst>
            </p:cNvPr>
            <p:cNvSpPr txBox="1"/>
            <p:nvPr/>
          </p:nvSpPr>
          <p:spPr>
            <a:xfrm>
              <a:off x="1125294" y="3841028"/>
              <a:ext cx="1555138" cy="5336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linical Outcomes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3586760C-AA6C-463C-A7F3-858BA69DA4C5}"/>
              </a:ext>
            </a:extLst>
          </p:cNvPr>
          <p:cNvGrpSpPr/>
          <p:nvPr/>
        </p:nvGrpSpPr>
        <p:grpSpPr>
          <a:xfrm>
            <a:off x="5264048" y="3185098"/>
            <a:ext cx="6517614" cy="1453088"/>
            <a:chOff x="1086928" y="4501917"/>
            <a:chExt cx="5944212" cy="1095514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AAEE026-BCDA-407C-BA30-930CA2078003}"/>
                </a:ext>
              </a:extLst>
            </p:cNvPr>
            <p:cNvSpPr txBox="1"/>
            <p:nvPr/>
          </p:nvSpPr>
          <p:spPr>
            <a:xfrm>
              <a:off x="3910601" y="4754178"/>
              <a:ext cx="3119926" cy="7077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801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Longer hospital length of stay</a:t>
              </a:r>
            </a:p>
            <a:p>
              <a:pPr marL="0" marR="0" lvl="0" indent="0" algn="l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801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Higher readmission rate</a:t>
              </a:r>
            </a:p>
          </p:txBody>
        </p: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590564B3-6F2E-4B41-B782-C66B03C1B0D1}"/>
                </a:ext>
              </a:extLst>
            </p:cNvPr>
            <p:cNvGrpSpPr/>
            <p:nvPr/>
          </p:nvGrpSpPr>
          <p:grpSpPr>
            <a:xfrm>
              <a:off x="3240145" y="4633617"/>
              <a:ext cx="551554" cy="951789"/>
              <a:chOff x="3240145" y="4631086"/>
              <a:chExt cx="551554" cy="951789"/>
            </a:xfrm>
          </p:grpSpPr>
          <p:pic>
            <p:nvPicPr>
              <p:cNvPr id="41" name="Picture 4" descr="Increase ">
                <a:extLst>
                  <a:ext uri="{FF2B5EF4-FFF2-40B4-BE49-F238E27FC236}">
                    <a16:creationId xmlns:a16="http://schemas.microsoft.com/office/drawing/2014/main" id="{ADEF7C4E-350B-4CDA-90A2-D2A74614A74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09153" y="5153048"/>
                <a:ext cx="429827" cy="42982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82D6FD28-FDDA-44D5-A9B7-6DB20082B446}"/>
                  </a:ext>
                </a:extLst>
              </p:cNvPr>
              <p:cNvGrpSpPr/>
              <p:nvPr/>
            </p:nvGrpSpPr>
            <p:grpSpPr>
              <a:xfrm>
                <a:off x="3240145" y="4631086"/>
                <a:ext cx="551554" cy="551554"/>
                <a:chOff x="7655818" y="3666763"/>
                <a:chExt cx="914400" cy="914400"/>
              </a:xfrm>
            </p:grpSpPr>
            <p:pic>
              <p:nvPicPr>
                <p:cNvPr id="43" name="Graphic 42" descr="Monthly calendar outline">
                  <a:extLst>
                    <a:ext uri="{FF2B5EF4-FFF2-40B4-BE49-F238E27FC236}">
                      <a16:creationId xmlns:a16="http://schemas.microsoft.com/office/drawing/2014/main" id="{010A7948-99C2-4447-816B-844A61D564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8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655818" y="3666763"/>
                  <a:ext cx="914400" cy="914400"/>
                </a:xfrm>
                <a:prstGeom prst="rect">
                  <a:avLst/>
                </a:prstGeom>
              </p:spPr>
            </p:pic>
            <p:cxnSp>
              <p:nvCxnSpPr>
                <p:cNvPr id="44" name="Straight Arrow Connector 43">
                  <a:extLst>
                    <a:ext uri="{FF2B5EF4-FFF2-40B4-BE49-F238E27FC236}">
                      <a16:creationId xmlns:a16="http://schemas.microsoft.com/office/drawing/2014/main" id="{0C890AC3-9FD6-4DDF-BEEB-815F9F885C12}"/>
                    </a:ext>
                  </a:extLst>
                </p:cNvPr>
                <p:cNvCxnSpPr/>
                <p:nvPr/>
              </p:nvCxnSpPr>
              <p:spPr>
                <a:xfrm>
                  <a:off x="7893045" y="4123963"/>
                  <a:ext cx="439948" cy="0"/>
                </a:xfrm>
                <a:prstGeom prst="straightConnector1">
                  <a:avLst/>
                </a:prstGeom>
                <a:noFill/>
                <a:ln w="12700" cap="flat" cmpd="sng" algn="ctr">
                  <a:solidFill>
                    <a:srgbClr val="000000"/>
                  </a:solidFill>
                  <a:prstDash val="solid"/>
                  <a:miter lim="800000"/>
                  <a:tailEnd type="stealth"/>
                </a:ln>
                <a:effectLst/>
              </p:spPr>
            </p:cxnSp>
            <p:cxnSp>
              <p:nvCxnSpPr>
                <p:cNvPr id="45" name="Straight Arrow Connector 44">
                  <a:extLst>
                    <a:ext uri="{FF2B5EF4-FFF2-40B4-BE49-F238E27FC236}">
                      <a16:creationId xmlns:a16="http://schemas.microsoft.com/office/drawing/2014/main" id="{B4E60FC6-3044-4B31-B58A-889DD152220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893045" y="4219635"/>
                  <a:ext cx="349028" cy="0"/>
                </a:xfrm>
                <a:prstGeom prst="straightConnector1">
                  <a:avLst/>
                </a:prstGeom>
                <a:noFill/>
                <a:ln w="12700" cap="flat" cmpd="sng" algn="ctr">
                  <a:solidFill>
                    <a:srgbClr val="000000"/>
                  </a:solidFill>
                  <a:prstDash val="solid"/>
                  <a:miter lim="800000"/>
                  <a:tailEnd type="stealth"/>
                </a:ln>
                <a:effectLst/>
              </p:spPr>
            </p:cxnSp>
          </p:grpSp>
        </p:grp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F78B867B-F700-4406-85F0-A19D5C260BC8}"/>
                </a:ext>
              </a:extLst>
            </p:cNvPr>
            <p:cNvSpPr/>
            <p:nvPr/>
          </p:nvSpPr>
          <p:spPr>
            <a:xfrm>
              <a:off x="2398143" y="4628647"/>
              <a:ext cx="4632997" cy="968784"/>
            </a:xfrm>
            <a:prstGeom prst="rect">
              <a:avLst/>
            </a:prstGeom>
            <a:noFill/>
            <a:ln w="12700" cap="flat" cmpd="sng" algn="ctr">
              <a:solidFill>
                <a:srgbClr val="282A6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Arrow: Pentagon 38">
              <a:extLst>
                <a:ext uri="{FF2B5EF4-FFF2-40B4-BE49-F238E27FC236}">
                  <a16:creationId xmlns:a16="http://schemas.microsoft.com/office/drawing/2014/main" id="{7397F77D-6C1A-45B5-8D4A-C76005AEDC30}"/>
                </a:ext>
              </a:extLst>
            </p:cNvPr>
            <p:cNvSpPr/>
            <p:nvPr/>
          </p:nvSpPr>
          <p:spPr>
            <a:xfrm>
              <a:off x="1086928" y="4623113"/>
              <a:ext cx="1929396" cy="972798"/>
            </a:xfrm>
            <a:prstGeom prst="homePlate">
              <a:avLst/>
            </a:prstGeom>
            <a:solidFill>
              <a:srgbClr val="282A65"/>
            </a:solidFill>
            <a:ln w="12700" cap="flat" cmpd="sng" algn="ctr">
              <a:solidFill>
                <a:srgbClr val="282A6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826D544-2313-44BE-B398-B8A1B0F54303}"/>
                </a:ext>
              </a:extLst>
            </p:cNvPr>
            <p:cNvSpPr txBox="1"/>
            <p:nvPr/>
          </p:nvSpPr>
          <p:spPr>
            <a:xfrm>
              <a:off x="1155852" y="4501917"/>
              <a:ext cx="1428685" cy="9977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1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Health Resource Utilization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603320CD-C1D0-4B3F-AAA3-1D03DBFCD425}"/>
              </a:ext>
            </a:extLst>
          </p:cNvPr>
          <p:cNvGrpSpPr/>
          <p:nvPr/>
        </p:nvGrpSpPr>
        <p:grpSpPr>
          <a:xfrm>
            <a:off x="5264048" y="4739557"/>
            <a:ext cx="6611527" cy="1293123"/>
            <a:chOff x="1086927" y="5658983"/>
            <a:chExt cx="6029863" cy="960901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3A2EECE-729F-459C-B94D-86A85DA3C075}"/>
                </a:ext>
              </a:extLst>
            </p:cNvPr>
            <p:cNvSpPr txBox="1"/>
            <p:nvPr/>
          </p:nvSpPr>
          <p:spPr>
            <a:xfrm>
              <a:off x="3910602" y="5852896"/>
              <a:ext cx="3206188" cy="5260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601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Higher adjusted total reimbursements</a:t>
              </a:r>
            </a:p>
          </p:txBody>
        </p:sp>
        <p:pic>
          <p:nvPicPr>
            <p:cNvPr id="48" name="Picture 4" descr="Increase ">
              <a:extLst>
                <a:ext uri="{FF2B5EF4-FFF2-40B4-BE49-F238E27FC236}">
                  <a16:creationId xmlns:a16="http://schemas.microsoft.com/office/drawing/2014/main" id="{C0BD8335-ECCE-4180-8735-94E7C481DB6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09153" y="5926644"/>
              <a:ext cx="429827" cy="42982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D51A7024-1E25-47D3-BDC7-43113C8B40D8}"/>
                </a:ext>
              </a:extLst>
            </p:cNvPr>
            <p:cNvSpPr/>
            <p:nvPr/>
          </p:nvSpPr>
          <p:spPr>
            <a:xfrm>
              <a:off x="2397530" y="5658983"/>
              <a:ext cx="4632997" cy="958064"/>
            </a:xfrm>
            <a:prstGeom prst="rect">
              <a:avLst/>
            </a:prstGeom>
            <a:noFill/>
            <a:ln w="12700" cap="flat" cmpd="sng" algn="ctr">
              <a:solidFill>
                <a:srgbClr val="421B5D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Arrow: Pentagon 49">
              <a:extLst>
                <a:ext uri="{FF2B5EF4-FFF2-40B4-BE49-F238E27FC236}">
                  <a16:creationId xmlns:a16="http://schemas.microsoft.com/office/drawing/2014/main" id="{68F322F9-2DB5-4983-BA5C-B7DDDFA3C875}"/>
                </a:ext>
              </a:extLst>
            </p:cNvPr>
            <p:cNvSpPr/>
            <p:nvPr/>
          </p:nvSpPr>
          <p:spPr>
            <a:xfrm>
              <a:off x="1086927" y="5661821"/>
              <a:ext cx="1929396" cy="958063"/>
            </a:xfrm>
            <a:prstGeom prst="homePlate">
              <a:avLst/>
            </a:prstGeom>
            <a:solidFill>
              <a:srgbClr val="421B5D"/>
            </a:solidFill>
            <a:ln w="12700" cap="flat" cmpd="sng" algn="ctr">
              <a:solidFill>
                <a:srgbClr val="421B5D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36FAECB-DD58-48CA-8339-DE2EA1D80038}"/>
                </a:ext>
              </a:extLst>
            </p:cNvPr>
            <p:cNvSpPr txBox="1"/>
            <p:nvPr/>
          </p:nvSpPr>
          <p:spPr>
            <a:xfrm>
              <a:off x="1157226" y="5908171"/>
              <a:ext cx="1494219" cy="5260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1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conomic Outcomes</a:t>
              </a:r>
            </a:p>
          </p:txBody>
        </p:sp>
      </p:grp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4EC3892B-C104-4D67-8ED5-46FCC01E8199}"/>
              </a:ext>
            </a:extLst>
          </p:cNvPr>
          <p:cNvCxnSpPr>
            <a:cxnSpLocks/>
          </p:cNvCxnSpPr>
          <p:nvPr/>
        </p:nvCxnSpPr>
        <p:spPr>
          <a:xfrm>
            <a:off x="2466349" y="3903987"/>
            <a:ext cx="0" cy="251209"/>
          </a:xfrm>
          <a:prstGeom prst="straightConnector1">
            <a:avLst/>
          </a:prstGeom>
          <a:noFill/>
          <a:ln w="6350" cap="flat" cmpd="sng" algn="ctr">
            <a:solidFill>
              <a:srgbClr val="000000"/>
            </a:solidFill>
            <a:prstDash val="solid"/>
            <a:miter lim="800000"/>
            <a:tailEnd type="triangle"/>
          </a:ln>
          <a:effectLst/>
        </p:spPr>
      </p:cxnSp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C99C8BFBF5CDC4583214576B515D35C" ma:contentTypeVersion="16" ma:contentTypeDescription="Create a new document." ma:contentTypeScope="" ma:versionID="5c5148496adc9fa598a2be429ee1c393">
  <xsd:schema xmlns:xsd="http://www.w3.org/2001/XMLSchema" xmlns:xs="http://www.w3.org/2001/XMLSchema" xmlns:p="http://schemas.microsoft.com/office/2006/metadata/properties" xmlns:ns2="ebd2572b-60f9-4e12-bc9a-0e564e42b42d" xmlns:ns3="5b7801e2-7e3c-418c-a5bd-c56f904092f9" targetNamespace="http://schemas.microsoft.com/office/2006/metadata/properties" ma:root="true" ma:fieldsID="14c4f4583a70a2905e4131bc1e7342d0" ns2:_="" ns3:_="">
    <xsd:import namespace="ebd2572b-60f9-4e12-bc9a-0e564e42b42d"/>
    <xsd:import namespace="5b7801e2-7e3c-418c-a5bd-c56f904092f9"/>
    <xsd:element name="properties">
      <xsd:complexType>
        <xsd:sequence>
          <xsd:element name="documentManagement">
            <xsd:complexType>
              <xsd:all>
                <xsd:element ref="ns3:TaxCatchAll" minOccurs="0"/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h995aa0ed874422cbca5d84bea3b7546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bd2572b-60f9-4e12-bc9a-0e564e42b42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h995aa0ed874422cbca5d84bea3b7546" ma:index="14" ma:taxonomy="true" ma:internalName="h995aa0ed874422cbca5d84bea3b7546" ma:taxonomyFieldName="Job_x0020_Number" ma:displayName="Job Number" ma:readOnly="false" ma:fieldId="{1995aa0e-d874-422c-bca5-d84bea3b7546}" ma:sspId="fafcaaa8-e7a8-44c2-933f-ce44cd872c25" ma:termSetId="019dd6cc-754f-4e15-8ee2-13770c0a2852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b7801e2-7e3c-418c-a5bd-c56f904092f9" elementFormDefault="qualified">
    <xsd:import namespace="http://schemas.microsoft.com/office/2006/documentManagement/types"/>
    <xsd:import namespace="http://schemas.microsoft.com/office/infopath/2007/PartnerControls"/>
    <xsd:element name="TaxCatchAll" ma:index="9" nillable="true" ma:displayName="Taxonomy Catch All Column" ma:hidden="true" ma:list="{3c0f3b84-6644-463e-a682-f7e61ba52f20}" ma:internalName="TaxCatchAll" ma:showField="CatchAllData" ma:web="5b7801e2-7e3c-418c-a5bd-c56f904092f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7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h995aa0ed874422cbca5d84bea3b7546 xmlns="ebd2572b-60f9-4e12-bc9a-0e564e42b42d">
      <Terms xmlns="http://schemas.microsoft.com/office/infopath/2007/PartnerControls">
        <TermInfo xmlns="http://schemas.microsoft.com/office/infopath/2007/PartnerControls">
          <TermName xmlns="http://schemas.microsoft.com/office/infopath/2007/PartnerControls">9744-00</TermName>
          <TermId xmlns="http://schemas.microsoft.com/office/infopath/2007/PartnerControls">362d19ba-4a90-4b2e-9462-31bda92b396f</TermId>
        </TermInfo>
      </Terms>
    </h995aa0ed874422cbca5d84bea3b7546>
    <TaxCatchAll xmlns="5b7801e2-7e3c-418c-a5bd-c56f904092f9">
      <Value>3</Value>
    </TaxCatchAll>
  </documentManagement>
</p:properties>
</file>

<file path=customXml/itemProps1.xml><?xml version="1.0" encoding="utf-8"?>
<ds:datastoreItem xmlns:ds="http://schemas.openxmlformats.org/officeDocument/2006/customXml" ds:itemID="{49A36D29-318E-4DE0-A885-960322562BA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5B37408-3709-443E-95CB-50EA14AFC39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bd2572b-60f9-4e12-bc9a-0e564e42b42d"/>
    <ds:schemaRef ds:uri="5b7801e2-7e3c-418c-a5bd-c56f904092f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7221702-6B30-4490-A475-B71EA9809DD7}">
  <ds:schemaRefs>
    <ds:schemaRef ds:uri="http://schemas.microsoft.com/office/infopath/2007/PartnerControls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dcmitype/"/>
    <ds:schemaRef ds:uri="5b7801e2-7e3c-418c-a5bd-c56f904092f9"/>
    <ds:schemaRef ds:uri="http://purl.org/dc/terms/"/>
    <ds:schemaRef ds:uri="ebd2572b-60f9-4e12-bc9a-0e564e42b42d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84</TotalTime>
  <Words>135</Words>
  <Application>Microsoft Macintosh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soleucel (ALVR105), an Off-the-Shelf,Multivirus-Specific T-Cell Therapy, for thePrevention of Viral Infections Post-HCT: Resultsfrom an Open-Label Cohort of a Phase 2 Trial</dc:title>
  <dc:creator>Michelle Matzko</dc:creator>
  <cp:lastModifiedBy>Michael G Ison</cp:lastModifiedBy>
  <cp:revision>102</cp:revision>
  <dcterms:created xsi:type="dcterms:W3CDTF">2021-10-14T23:02:11Z</dcterms:created>
  <dcterms:modified xsi:type="dcterms:W3CDTF">2022-05-25T22:36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C99C8BFBF5CDC4583214576B515D35C</vt:lpwstr>
  </property>
  <property fmtid="{D5CDD505-2E9C-101B-9397-08002B2CF9AE}" pid="3" name="Job Number">
    <vt:lpwstr>3;#9744-00|362d19ba-4a90-4b2e-9462-31bda92b396f</vt:lpwstr>
  </property>
</Properties>
</file>